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0" autoAdjust="0"/>
    <p:restoredTop sz="94694" autoAdjust="0"/>
  </p:normalViewPr>
  <p:slideViewPr>
    <p:cSldViewPr snapToGrid="0">
      <p:cViewPr>
        <p:scale>
          <a:sx n="160" d="100"/>
          <a:sy n="160" d="100"/>
        </p:scale>
        <p:origin x="-786" y="82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ko-KR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8905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77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0402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4107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0324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1456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4698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7571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815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6423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ko-KR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7077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895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014" b="20376"/>
          <a:stretch/>
        </p:blipFill>
        <p:spPr bwMode="auto">
          <a:xfrm>
            <a:off x="560388" y="932507"/>
            <a:ext cx="5737225" cy="27820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640611" y="3820494"/>
            <a:ext cx="557943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The sequence alignment of PERV molecular clone B (EU23109) with PCR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duct from the genomic DNA of cells treated with serum of transplanted NOG mouse. </a:t>
            </a: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nomic DNA was isolated from 293T cells, which were treated with serum from NOG mice transplanted with PERV/NIH3T3 cells.  Nested PCR product using pol1, pol2, pol3, and pol4 as primers was cloned to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EM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sy vector and the pol sequence was compared with PERV molecular clone B (EU23109).</a:t>
            </a:r>
          </a:p>
        </p:txBody>
      </p:sp>
    </p:spTree>
    <p:extLst>
      <p:ext uri="{BB962C8B-B14F-4D97-AF65-F5344CB8AC3E}">
        <p14:creationId xmlns:p14="http://schemas.microsoft.com/office/powerpoint/2010/main" val="27111841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</TotalTime>
  <Words>88</Words>
  <Application>Microsoft Office PowerPoint</Application>
  <PresentationFormat>화면 슬라이드 쇼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Theme</vt:lpstr>
      <vt:lpstr>PowerPoint 프레젠테이션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me</dc:creator>
  <cp:lastModifiedBy>Windows User</cp:lastModifiedBy>
  <cp:revision>14</cp:revision>
  <dcterms:created xsi:type="dcterms:W3CDTF">2016-07-13T13:08:54Z</dcterms:created>
  <dcterms:modified xsi:type="dcterms:W3CDTF">2016-10-14T10:41:15Z</dcterms:modified>
</cp:coreProperties>
</file>